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76" d="100"/>
          <a:sy n="76" d="100"/>
        </p:scale>
        <p:origin x="1586" y="43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974A2-4309-4762-B98E-9CA842F6E07B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1B375-9AE0-4C19-9DFF-587E2E1D5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639675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974A2-4309-4762-B98E-9CA842F6E07B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1B375-9AE0-4C19-9DFF-587E2E1D5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45035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974A2-4309-4762-B98E-9CA842F6E07B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1B375-9AE0-4C19-9DFF-587E2E1D5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3598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974A2-4309-4762-B98E-9CA842F6E07B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1B375-9AE0-4C19-9DFF-587E2E1D5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9642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974A2-4309-4762-B98E-9CA842F6E07B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1B375-9AE0-4C19-9DFF-587E2E1D5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04161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974A2-4309-4762-B98E-9CA842F6E07B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1B375-9AE0-4C19-9DFF-587E2E1D5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02069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974A2-4309-4762-B98E-9CA842F6E07B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1B375-9AE0-4C19-9DFF-587E2E1D5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4525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974A2-4309-4762-B98E-9CA842F6E07B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1B375-9AE0-4C19-9DFF-587E2E1D5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33541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974A2-4309-4762-B98E-9CA842F6E07B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1B375-9AE0-4C19-9DFF-587E2E1D5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16267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974A2-4309-4762-B98E-9CA842F6E07B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1B375-9AE0-4C19-9DFF-587E2E1D5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949080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974A2-4309-4762-B98E-9CA842F6E07B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1B375-9AE0-4C19-9DFF-587E2E1D5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8522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E974A2-4309-4762-B98E-9CA842F6E07B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01B375-9AE0-4C19-9DFF-587E2E1D53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372994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028906" y="548680"/>
            <a:ext cx="3429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i="1" dirty="0">
                <a:latin typeface="Arial" panose="020B0604020202020204" pitchFamily="34" charset="0"/>
                <a:cs typeface="Arial" panose="020B0604020202020204" pitchFamily="34" charset="0"/>
              </a:rPr>
              <a:t>WT    KO    WT   KO   WT   KO    WT   KO   </a:t>
            </a:r>
            <a:r>
              <a:rPr lang="de-DE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1244010" y="764706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i="1" dirty="0">
                <a:latin typeface="Arial" panose="020B0604020202020204" pitchFamily="34" charset="0"/>
                <a:cs typeface="Arial" panose="020B0604020202020204" pitchFamily="34" charset="0"/>
              </a:rPr>
              <a:t>III F3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2008556" y="764705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i="1" dirty="0">
                <a:latin typeface="Arial" panose="020B0604020202020204" pitchFamily="34" charset="0"/>
                <a:cs typeface="Arial" panose="020B0604020202020204" pitchFamily="34" charset="0"/>
              </a:rPr>
              <a:t>III F3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2726558" y="764707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i="1" dirty="0">
                <a:latin typeface="Arial" panose="020B0604020202020204" pitchFamily="34" charset="0"/>
                <a:cs typeface="Arial" panose="020B0604020202020204" pitchFamily="34" charset="0"/>
              </a:rPr>
              <a:t>III F3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3437099" y="764707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i="1" dirty="0">
                <a:latin typeface="Arial" panose="020B0604020202020204" pitchFamily="34" charset="0"/>
                <a:cs typeface="Arial" panose="020B0604020202020204" pitchFamily="34" charset="0"/>
              </a:rPr>
              <a:t>I E12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3861930" y="764704"/>
            <a:ext cx="4940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i="1" dirty="0">
                <a:latin typeface="Arial" panose="020B0604020202020204" pitchFamily="34" charset="0"/>
                <a:cs typeface="Arial" panose="020B0604020202020204" pitchFamily="34" charset="0"/>
              </a:rPr>
              <a:t>II F1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1860146" y="238956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3661561" y="238956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i="1" dirty="0">
                <a:latin typeface="Arial" panose="020B0604020202020204" pitchFamily="34" charset="0"/>
                <a:cs typeface="Arial" panose="020B0604020202020204" pitchFamily="34" charset="0"/>
              </a:rPr>
              <a:t>HEK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8" t="248" r="2779" b="-952"/>
          <a:stretch/>
        </p:blipFill>
        <p:spPr bwMode="auto">
          <a:xfrm>
            <a:off x="251520" y="1257727"/>
            <a:ext cx="4320480" cy="34563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487" t="93" r="-1257" b="-1036"/>
          <a:stretch/>
        </p:blipFill>
        <p:spPr>
          <a:xfrm>
            <a:off x="4932040" y="1110135"/>
            <a:ext cx="4176464" cy="3096344"/>
          </a:xfrm>
          <a:prstGeom prst="rect">
            <a:avLst/>
          </a:prstGeom>
        </p:spPr>
      </p:pic>
      <p:cxnSp>
        <p:nvCxnSpPr>
          <p:cNvPr id="27" name="Gerade Verbindung 26"/>
          <p:cNvCxnSpPr/>
          <p:nvPr/>
        </p:nvCxnSpPr>
        <p:spPr>
          <a:xfrm>
            <a:off x="1028906" y="515955"/>
            <a:ext cx="217494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 Verbindung 27"/>
          <p:cNvCxnSpPr/>
          <p:nvPr/>
        </p:nvCxnSpPr>
        <p:spPr>
          <a:xfrm>
            <a:off x="3405170" y="520632"/>
            <a:ext cx="1044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feld 28"/>
          <p:cNvSpPr txBox="1"/>
          <p:nvPr/>
        </p:nvSpPr>
        <p:spPr>
          <a:xfrm>
            <a:off x="2112491" y="4705399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TMBIM5</a:t>
            </a:r>
          </a:p>
        </p:txBody>
      </p:sp>
      <p:sp>
        <p:nvSpPr>
          <p:cNvPr id="30" name="Textfeld 29"/>
          <p:cNvSpPr txBox="1"/>
          <p:nvPr/>
        </p:nvSpPr>
        <p:spPr>
          <a:xfrm>
            <a:off x="6432971" y="4705399"/>
            <a:ext cx="7537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HSP60</a:t>
            </a:r>
          </a:p>
        </p:txBody>
      </p:sp>
      <p:sp>
        <p:nvSpPr>
          <p:cNvPr id="18" name="Textfeld 17"/>
          <p:cNvSpPr txBox="1"/>
          <p:nvPr/>
        </p:nvSpPr>
        <p:spPr>
          <a:xfrm>
            <a:off x="5175304" y="559710"/>
            <a:ext cx="3429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i="1" dirty="0">
                <a:latin typeface="Arial" panose="020B0604020202020204" pitchFamily="34" charset="0"/>
                <a:cs typeface="Arial" panose="020B0604020202020204" pitchFamily="34" charset="0"/>
              </a:rPr>
              <a:t>WT    KO    WT   KO   WT   KO    WT   KO   </a:t>
            </a:r>
            <a:r>
              <a:rPr lang="de-DE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5390408" y="775736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i="1" dirty="0">
                <a:latin typeface="Arial" panose="020B0604020202020204" pitchFamily="34" charset="0"/>
                <a:cs typeface="Arial" panose="020B0604020202020204" pitchFamily="34" charset="0"/>
              </a:rPr>
              <a:t>III F3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6154954" y="775735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i="1" dirty="0">
                <a:latin typeface="Arial" panose="020B0604020202020204" pitchFamily="34" charset="0"/>
                <a:cs typeface="Arial" panose="020B0604020202020204" pitchFamily="34" charset="0"/>
              </a:rPr>
              <a:t>III F3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6872956" y="775737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i="1" dirty="0">
                <a:latin typeface="Arial" panose="020B0604020202020204" pitchFamily="34" charset="0"/>
                <a:cs typeface="Arial" panose="020B0604020202020204" pitchFamily="34" charset="0"/>
              </a:rPr>
              <a:t>III F3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7583497" y="775737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i="1" dirty="0">
                <a:latin typeface="Arial" panose="020B0604020202020204" pitchFamily="34" charset="0"/>
                <a:cs typeface="Arial" panose="020B0604020202020204" pitchFamily="34" charset="0"/>
              </a:rPr>
              <a:t>I E12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8008328" y="775734"/>
            <a:ext cx="4940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i="1" dirty="0">
                <a:latin typeface="Arial" panose="020B0604020202020204" pitchFamily="34" charset="0"/>
                <a:cs typeface="Arial" panose="020B0604020202020204" pitchFamily="34" charset="0"/>
              </a:rPr>
              <a:t>II F1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6006544" y="249986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7807959" y="249986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i="1" dirty="0">
                <a:latin typeface="Arial" panose="020B0604020202020204" pitchFamily="34" charset="0"/>
                <a:cs typeface="Arial" panose="020B0604020202020204" pitchFamily="34" charset="0"/>
              </a:rPr>
              <a:t>HEK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Gerade Verbindung 26"/>
          <p:cNvCxnSpPr/>
          <p:nvPr/>
        </p:nvCxnSpPr>
        <p:spPr>
          <a:xfrm>
            <a:off x="5175304" y="526985"/>
            <a:ext cx="217494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 Verbindung 27"/>
          <p:cNvCxnSpPr/>
          <p:nvPr/>
        </p:nvCxnSpPr>
        <p:spPr>
          <a:xfrm>
            <a:off x="7551568" y="531662"/>
            <a:ext cx="1044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hteck 1"/>
          <p:cNvSpPr/>
          <p:nvPr/>
        </p:nvSpPr>
        <p:spPr>
          <a:xfrm>
            <a:off x="3297954" y="1978682"/>
            <a:ext cx="1127951" cy="586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6" name="Rechteck 35"/>
          <p:cNvSpPr/>
          <p:nvPr/>
        </p:nvSpPr>
        <p:spPr>
          <a:xfrm>
            <a:off x="1028907" y="1988840"/>
            <a:ext cx="831240" cy="57606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7" name="Rechteck 36"/>
          <p:cNvSpPr/>
          <p:nvPr/>
        </p:nvSpPr>
        <p:spPr>
          <a:xfrm>
            <a:off x="5317807" y="1588845"/>
            <a:ext cx="831240" cy="3999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8" name="Rechteck 37"/>
          <p:cNvSpPr/>
          <p:nvPr/>
        </p:nvSpPr>
        <p:spPr>
          <a:xfrm>
            <a:off x="7592708" y="1578688"/>
            <a:ext cx="1155756" cy="3999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31005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4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 Presentation</vt:lpstr>
    </vt:vector>
  </TitlesOfParts>
  <Company>Medizinische Universitaet Wi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arin</dc:creator>
  <cp:lastModifiedBy>Sami Elamin Mustafa Mohammed</cp:lastModifiedBy>
  <cp:revision>6</cp:revision>
  <dcterms:created xsi:type="dcterms:W3CDTF">2019-04-24T12:27:31Z</dcterms:created>
  <dcterms:modified xsi:type="dcterms:W3CDTF">2022-09-07T13:25:09Z</dcterms:modified>
</cp:coreProperties>
</file>